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0" autoAdjust="0"/>
    <p:restoredTop sz="81079" autoAdjust="0"/>
  </p:normalViewPr>
  <p:slideViewPr>
    <p:cSldViewPr snapToGrid="0">
      <p:cViewPr varScale="1">
        <p:scale>
          <a:sx n="106" d="100"/>
          <a:sy n="106" d="100"/>
        </p:scale>
        <p:origin x="47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2DE309-69C0-4863-AEA6-A94EF8E265F7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3AA22F-B494-4907-BA15-064B38F6BB5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35014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3AA22F-B494-4907-BA15-064B38F6BB5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1561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5157D23-D596-40AC-B397-6CCD7D9415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5FDC8B61-4755-4119-84B0-6C65A9F88D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6E247E8-8B4A-4863-A075-30341B2F4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D3735AD-8955-4183-B19C-F661882CE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DB4DBC-9FEA-44D6-9D1E-0D8BBDFB8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5455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5887862-19F4-4589-8769-10FBCF2064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7617473-4015-449E-8C08-922AF1A795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5FFFAFD-EF06-4D11-970F-76295B5DB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F86DC6F-6603-4E2F-825A-C1705C5CE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9CF7C78-4745-4A60-B2A8-8B2053DE9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8200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87823DD8-AB8C-400F-B5FB-A5DA6433EA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D2FC0F3-516C-4B94-8672-0B473FCC09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360FE96-3204-465E-9A47-C9455E06A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959A7A0-C515-4A30-9547-02AA65AB3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BFBD191-4B42-4487-81B9-D00A1FF64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4417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5B02E6-0F11-4B87-B7FF-41509A5ED4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7D7F634-E16B-4A73-B586-B01BDDD1A7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8829E2-9E1E-4D4C-B900-07410CFF1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1282967-9584-42A0-8885-950A257F8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3A33496-9B4B-485A-911D-1ACF5D7DD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5251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2755AD-B08F-40AE-939B-9F7AEE1682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192E20E-2B7B-415C-8D36-938FA47DF1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085EAA2-59FC-46D8-BD7E-280C90896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1BAD5D-D82C-47D0-BBF5-0075B0BAE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A9EF3AC-1266-43D7-9E4D-8E91682A5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2672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5117AEA-CC7A-4C62-A9EC-0A1C87371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FF391B1-75E6-49E0-832D-AE71E40616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2E70D89-604B-4822-9690-48135785A0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D9D3F52-8850-4117-880D-7F4B5C913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E1FBCAC-396C-46E4-8AA1-4C075DD61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8B1D130-6926-414E-94B1-E131212EC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6015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4197E12-9A0C-468E-8AB5-D8710A7F43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71B0062-CA54-4819-B8AB-33DD47A1CD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75DABCC-CF6C-4CF3-AA00-E4D311AA5F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DA791CFC-C4BB-4A98-A752-73257B86D9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222D344-EF7B-44B5-87B2-AF05CA1E84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10026A5-69C6-4003-8E50-BD84F6210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027292D-AD75-4226-BB10-0F0CA38A9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D056118-1FB7-4770-A3FD-7780013BE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6922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C17A6A-0C28-4823-9BCA-E0DB47054F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64E40CD8-3826-470A-BA74-C4A03CACC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079ED21-AF87-4060-8DC2-0B7E27835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CC4C77E9-EF99-4552-8CF6-C7BB6D20B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2313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35280C0C-606A-4CFF-8A2F-48E2ECD9A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D19F27C1-E8E9-4CC5-A1E9-510595604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CCABE7E-5321-429B-9EDE-656DF8FAA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7354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B5A315-E5B3-425F-800F-6499F6E5C6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8BF7889-9A91-420F-98F9-F488D0118A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9D4B7F0-140C-4E22-A0C9-42747F90E3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9499530-265F-4046-A89B-1F7162FE8B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1E45E69-C097-4BE2-BF9E-2D60244DC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AEE3752-802F-4B37-AE6F-72B3149F2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0763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C6FFC73-29ED-4586-ACCF-B525F802E9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3EC9F01-5778-4EE9-A339-3D5E23D4C4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CAFEDB3-69CD-47EA-BA3C-F96A107481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7C4D913-A788-4CAD-AEB6-9C5D3E628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88E2E4E-C916-4914-9B40-5EBE04897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6939188-44E8-4B3C-8727-2F39F263D7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731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283F88E-17E8-4DF5-B9B5-95832446D6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D9DC328-8AE5-40F9-8EDC-2536AC358E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4E7E8EA-BDEE-4C39-BE15-C40B875325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E04AEB1-E7A7-44B7-ABF5-3233BA2571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157F9BD-E586-4CB9-9241-8E6DB9902F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4009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17358" y="79580"/>
            <a:ext cx="6368377" cy="2899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latinLnBrk="0" hangingPunct="0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3. All experimental data of representative figures of a</a:t>
            </a:r>
            <a:r>
              <a:rPr lang="en-US" altLang="ko-KR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ptosis analysis </a:t>
            </a:r>
          </a:p>
        </p:txBody>
      </p:sp>
      <p:grpSp>
        <p:nvGrpSpPr>
          <p:cNvPr id="21" name="그룹 20"/>
          <p:cNvGrpSpPr/>
          <p:nvPr/>
        </p:nvGrpSpPr>
        <p:grpSpPr>
          <a:xfrm>
            <a:off x="961856" y="517241"/>
            <a:ext cx="5191111" cy="5753194"/>
            <a:chOff x="961856" y="517241"/>
            <a:chExt cx="5191111" cy="5753194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40" b="73184"/>
            <a:stretch/>
          </p:blipFill>
          <p:spPr>
            <a:xfrm>
              <a:off x="1221450" y="698642"/>
              <a:ext cx="3428676" cy="1839074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329" b="40753"/>
            <a:stretch/>
          </p:blipFill>
          <p:spPr>
            <a:xfrm>
              <a:off x="1174950" y="4287548"/>
              <a:ext cx="3521676" cy="1777431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6503" b="7982"/>
            <a:stretch/>
          </p:blipFill>
          <p:spPr>
            <a:xfrm>
              <a:off x="1128450" y="2537716"/>
              <a:ext cx="3521676" cy="1749832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4715847" y="1392328"/>
              <a:ext cx="1437119" cy="246221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Control</a:t>
              </a:r>
              <a:endPara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715847" y="3186781"/>
              <a:ext cx="1437119" cy="246221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Cyclophosphamide</a:t>
              </a:r>
              <a:endPara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715847" y="4950412"/>
              <a:ext cx="1437120" cy="246221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Etoposide</a:t>
              </a:r>
              <a:endPara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498669" y="517241"/>
              <a:ext cx="1437119" cy="246221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Unstained</a:t>
              </a:r>
              <a:endPara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074397" y="517241"/>
              <a:ext cx="1437119" cy="246221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Stained</a:t>
              </a:r>
              <a:endPara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13" name="직선 화살표 연결선 12"/>
            <p:cNvCxnSpPr/>
            <p:nvPr/>
          </p:nvCxnSpPr>
          <p:spPr>
            <a:xfrm flipH="1" flipV="1">
              <a:off x="1237792" y="739452"/>
              <a:ext cx="1284" cy="5302375"/>
            </a:xfrm>
            <a:prstGeom prst="straightConnector1">
              <a:avLst/>
            </a:prstGeom>
            <a:ln w="63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직선 화살표 연결선 13"/>
            <p:cNvCxnSpPr/>
            <p:nvPr/>
          </p:nvCxnSpPr>
          <p:spPr>
            <a:xfrm>
              <a:off x="1239074" y="6045002"/>
              <a:ext cx="3784516" cy="16800"/>
            </a:xfrm>
            <a:prstGeom prst="straightConnector1">
              <a:avLst/>
            </a:prstGeom>
            <a:ln w="63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 rot="16200000">
              <a:off x="429495" y="1216190"/>
              <a:ext cx="1280166" cy="215444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Propidium</a:t>
              </a:r>
              <a:r>
                <a:rPr lang="en-US" altLang="ko-KR" sz="8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 Iodide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954864" y="6054991"/>
              <a:ext cx="1113304" cy="215444"/>
            </a:xfrm>
            <a:prstGeom prst="rect">
              <a:avLst/>
            </a:prstGeom>
            <a:noFill/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Annexin</a:t>
              </a:r>
              <a:r>
                <a:rPr lang="en-US" altLang="ko-KR" sz="8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 V-FIT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60296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8</TotalTime>
  <Words>23</Words>
  <Application>Microsoft Office PowerPoint</Application>
  <PresentationFormat>와이드스크린</PresentationFormat>
  <Paragraphs>9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Arial Unicode MS</vt:lpstr>
      <vt:lpstr>맑은 고딕</vt:lpstr>
      <vt:lpstr>Arial</vt:lpstr>
      <vt:lpstr>Calibri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a-won Kang</dc:creator>
  <cp:lastModifiedBy>Administrator</cp:lastModifiedBy>
  <cp:revision>22</cp:revision>
  <dcterms:created xsi:type="dcterms:W3CDTF">2019-06-10T02:34:07Z</dcterms:created>
  <dcterms:modified xsi:type="dcterms:W3CDTF">2020-05-19T12:50:12Z</dcterms:modified>
</cp:coreProperties>
</file>